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412"/>
    <p:restoredTop sz="94564"/>
  </p:normalViewPr>
  <p:slideViewPr>
    <p:cSldViewPr snapToGrid="0" snapToObjects="1">
      <p:cViewPr varScale="1">
        <p:scale>
          <a:sx n="110" d="100"/>
          <a:sy n="110" d="100"/>
        </p:scale>
        <p:origin x="12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1C47FCC-A7DE-C54A-AF25-CF3134A986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AE7335D1-9E70-0F40-8D7A-5846EAE0A2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EE7B809-7739-2041-ABA9-A6904F399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7757A54-BC13-414D-8EE1-7BF7D104E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AFCF5D12-1CCC-BD4C-8210-4124CE6CC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204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1008995-ACAF-0946-AD65-4CE39C0BC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0488A24C-E8CB-B040-AA5D-806F652E39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24A3198-AF85-6A48-BD97-04AF11696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C9384A95-3E38-634E-B52B-B6724BCFE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6465BA2-750C-1741-B28D-3AF19FE8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159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1B74A11C-5EAD-384B-A797-CF6C3FC46D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BCC255D-C3D0-4B48-9811-29E6A0E1A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F087BCE-BC84-8A4B-A6DD-15DA3A7EA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0315A85-6106-0C47-BB9B-CB1C66D27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171A8F-7A7B-E844-9679-7577E733C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184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C211D9F-F5A1-7042-8E40-A09644020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4480A747-1346-9A49-8CBF-135E486DD6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431BFC2-859F-1548-8F03-2E015A16D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BA5BB7D-B8DC-604E-A60B-64B232C6B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689A912-A922-4A41-B698-98CAB56AD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60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158ABA-C837-7645-81F3-E22661BB4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A94E275-C56D-114A-973C-4B146AE16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71FC319-B4C7-C540-9A64-006870F32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F7601ED-9DB0-F74A-B8A5-4DDD44A65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4AFFA59A-9C30-4A4B-AB32-E5A44E5AD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492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6ED1D9D-1F13-7948-9876-A23D68E43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1F42A0A5-9A38-5845-8A12-BD65F65912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2014C03D-1629-774A-8077-08A08A9EF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AB58E07-2FEA-2A40-ADFD-E9B12B471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472D9183-631D-7746-83B7-606309008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08906376-8AEB-AF46-A0F7-89B6A08E6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8080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E2A39C2-238F-5F4A-89CE-D2FC66BC0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FD09BB6-60CB-A94E-96C5-91A64B38E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B8C6C03C-8CD1-6745-A502-D457C47E0E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6AA6C744-41E5-6146-BEBD-28F0102741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84BD8341-81E2-154C-9A40-E9F5E2055A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02EADBF0-605E-2242-8437-77C2770D0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897B657F-7620-314C-94A0-0644E7FA0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5476E10A-C084-5A44-8CE6-8BA554AD4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226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D9BC954-A6D5-4D4D-A357-3BC169A3E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C5A5F159-5A9B-0742-9BA5-346A8EFF2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EA834B68-E640-AA43-8D8A-8AA7BDA00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6EB35191-87D9-C947-AAA2-7F38B9D76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716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52860CFD-2CAE-514D-A399-5060F78F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51CB7B5-4807-4045-9E29-469425F39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445DFEF4-31E9-EF4C-8A54-2A7E38C1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68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8C810C-9DFA-104C-8724-BC1B25055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961EEE8-83FB-4940-BC3D-85AEC4914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DB4D2E8-AF5C-2541-9208-2C51333DD8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E9E150B-D3DF-9F4E-B6FB-9A8D2BD9C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67CB1BD0-B1C2-844B-882F-CA2A1C544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C522ED37-4F7C-8748-B605-C66B9D08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44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58696F9-A462-7B44-AB22-FA5F96AEB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FD8D893F-F9F7-D64D-9627-711FD95FAC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431A3F29-4BD5-8C4E-AD6B-C3D3195147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EEB28BA0-189F-CE4B-A0AB-327D0862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3FCC168-F240-2343-9B8F-E39D54BF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9868A88-B99D-2742-A011-FF14528AE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5648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9BEB9B36-CA2C-8B46-91F3-5CCF05EF5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F77A482A-3857-8046-8B6A-FCB532505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F433CD6-F44C-094C-A03F-9BE1DF0733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11BA33E-3BD6-BC40-BAE0-7AB6FA3AA6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F73945D-303E-4B43-8388-09D2C9354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16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748FA6AB-663C-A74D-B8E6-546F99799570}"/>
              </a:ext>
            </a:extLst>
          </p:cNvPr>
          <p:cNvSpPr txBox="1"/>
          <p:nvPr/>
        </p:nvSpPr>
        <p:spPr>
          <a:xfrm>
            <a:off x="1088168" y="5639079"/>
            <a:ext cx="100336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Additional file 4. Correlations.  </a:t>
            </a:r>
            <a:r>
              <a:rPr lang="en-US" sz="1400" dirty="0"/>
              <a:t>A, Correlation between baseline plasma vitamin C levels and baseline </a:t>
            </a:r>
            <a:r>
              <a:rPr lang="en-US" sz="1400" dirty="0" err="1"/>
              <a:t>Ach</a:t>
            </a:r>
            <a:r>
              <a:rPr lang="en-US" sz="1400" dirty="0"/>
              <a:t>-induced microvascular blood flow. B, Correlation between baseline plasma vitamin C levels and variations of </a:t>
            </a:r>
            <a:r>
              <a:rPr lang="en-US" sz="1400" dirty="0" err="1"/>
              <a:t>Ach</a:t>
            </a:r>
            <a:r>
              <a:rPr lang="en-US" sz="1400" dirty="0"/>
              <a:t>-induced microvascular blood flow after supplementation. (Pearson’s correlation)</a:t>
            </a:r>
            <a:endParaRPr lang="fr-FR" sz="1400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xmlns="" id="{40A36B92-6AB2-E242-BCFC-4967069A04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2816" y="1804738"/>
            <a:ext cx="7793632" cy="2792997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24C8DAA4-173B-C741-9F30-E78F6614F336}"/>
              </a:ext>
            </a:extLst>
          </p:cNvPr>
          <p:cNvSpPr txBox="1"/>
          <p:nvPr/>
        </p:nvSpPr>
        <p:spPr>
          <a:xfrm>
            <a:off x="2634917" y="152800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96B5A190-5B87-704F-AADA-1653773E9C88}"/>
              </a:ext>
            </a:extLst>
          </p:cNvPr>
          <p:cNvSpPr txBox="1"/>
          <p:nvPr/>
        </p:nvSpPr>
        <p:spPr>
          <a:xfrm>
            <a:off x="6521114" y="152800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932792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4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Femina P.</cp:lastModifiedBy>
  <cp:revision>16</cp:revision>
  <dcterms:created xsi:type="dcterms:W3CDTF">2021-09-29T14:29:35Z</dcterms:created>
  <dcterms:modified xsi:type="dcterms:W3CDTF">2022-01-10T12:08:32Z</dcterms:modified>
</cp:coreProperties>
</file>